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387" r:id="rId2"/>
    <p:sldId id="497" r:id="rId3"/>
    <p:sldId id="390" r:id="rId4"/>
    <p:sldId id="392" r:id="rId5"/>
    <p:sldId id="394" r:id="rId6"/>
    <p:sldId id="495" r:id="rId7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6600"/>
    <a:srgbClr val="3A79B8"/>
    <a:srgbClr val="B8B82A"/>
    <a:srgbClr val="B9742E"/>
    <a:srgbClr val="07AC82"/>
    <a:srgbClr val="FF99CC"/>
    <a:srgbClr val="FFCC66"/>
    <a:srgbClr val="FFFF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89933" autoAdjust="0"/>
  </p:normalViewPr>
  <p:slideViewPr>
    <p:cSldViewPr snapToGrid="0">
      <p:cViewPr varScale="1">
        <p:scale>
          <a:sx n="56" d="100"/>
          <a:sy n="56" d="100"/>
        </p:scale>
        <p:origin x="1044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50D5380-B092-44E7-8BA7-B0841A9B30AE}" type="datetimeFigureOut">
              <a:rPr lang="zh-CN" altLang="en-US" smtClean="0"/>
              <a:t>2022/7/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945E670-ACAA-48B5-8393-BACE3E0F01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658757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945E670-ACAA-48B5-8393-BACE3E0F010C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831342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945E670-ACAA-48B5-8393-BACE3E0F010C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9155118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945E670-ACAA-48B5-8393-BACE3E0F010C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807824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945E670-ACAA-48B5-8393-BACE3E0F010C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4458458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b="0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945E670-ACAA-48B5-8393-BACE3E0F010C}" type="slidenum">
              <a:rPr lang="zh-CN" altLang="en-US" smtClean="0"/>
              <a:t>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8825269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945E670-ACAA-48B5-8393-BACE3E0F010C}" type="slidenum">
              <a:rPr lang="zh-CN" altLang="en-US" smtClean="0"/>
              <a:t>6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694964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89FAFFC-E5C7-41D9-88DA-3E91937BF9D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EF01BB9D-E765-4858-8FFB-AD72D7FA9EF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2326FD9-E852-4CC0-8108-0B0B3EDBC3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0862F2-09E5-41ED-99C3-A82D329E9E4A}" type="datetimeFigureOut">
              <a:rPr lang="zh-CN" altLang="en-US" smtClean="0"/>
              <a:t>2022/7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D06B016-7304-478B-A637-1A55ECEE21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6C26432-3C3F-4E5C-9BA7-7C09CF9818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14234A-F86E-403E-BAE2-B71646D6545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77082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D4F85EA-F9F6-497D-8379-AC86BD23DC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EF582D8-A017-49F4-B077-722823120FC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7710BE0-2FED-450F-B558-3FDA8F9183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0862F2-09E5-41ED-99C3-A82D329E9E4A}" type="datetimeFigureOut">
              <a:rPr lang="zh-CN" altLang="en-US" smtClean="0"/>
              <a:t>2022/7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254FA8A-643C-4C5D-BFF1-A09AA3ACF7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D87105C-C7A6-48E5-A599-1A57141BD9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14234A-F86E-403E-BAE2-B71646D6545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11280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D709F7F7-1931-4CA7-A265-C142507C1FC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365F892-3B9A-4D20-9164-0D3A2F4CCE1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0F10073-D29A-488A-AB08-99D2BDF0C5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0862F2-09E5-41ED-99C3-A82D329E9E4A}" type="datetimeFigureOut">
              <a:rPr lang="zh-CN" altLang="en-US" smtClean="0"/>
              <a:t>2022/7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68B0326-1AAF-412F-B8A0-FF3A7ACF48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0ED438C-B0B5-415F-B503-6A4D327C62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14234A-F86E-403E-BAE2-B71646D6545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830790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01CA89F-E183-4BD9-AB81-0FA5189813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3C5CEC4-935D-42BA-A815-DFBFDA105B3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2AE14C0-7A7E-4855-A0FA-77508CCCC5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0862F2-09E5-41ED-99C3-A82D329E9E4A}" type="datetimeFigureOut">
              <a:rPr lang="zh-CN" altLang="en-US" smtClean="0"/>
              <a:t>2022/7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0F87C83-B1DF-43EB-9574-6ED3E80558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9962B88-94D8-4C13-8052-591E57196C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14234A-F86E-403E-BAE2-B71646D6545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1331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4BE4C49-F8C7-429C-BC44-39199AD89B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CBBDE19-EFDA-47AB-A5C8-C97FC6B6E1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B900C56-5A4D-4B63-975E-363C43A60C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0862F2-09E5-41ED-99C3-A82D329E9E4A}" type="datetimeFigureOut">
              <a:rPr lang="zh-CN" altLang="en-US" smtClean="0"/>
              <a:t>2022/7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0C64412-CD9F-494B-91B5-1043B15DA6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07D7847-ED18-4302-862F-3F2AF12934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14234A-F86E-403E-BAE2-B71646D6545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828860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FE9DA9A-AE81-4668-9139-AF6892ECDD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4FCE6CA-1D3B-47B0-B955-0EDDF0388F7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6983244-D40F-4BAA-B013-867BA88312B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45DCBE8-C06A-4015-9DFC-5B8876F2F6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0862F2-09E5-41ED-99C3-A82D329E9E4A}" type="datetimeFigureOut">
              <a:rPr lang="zh-CN" altLang="en-US" smtClean="0"/>
              <a:t>2022/7/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AB37C31-8779-4085-96E9-B1F882C954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69D50CF-CC7B-4112-83CF-BAC2AB8220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14234A-F86E-403E-BAE2-B71646D6545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30192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2B20F4F-3090-4029-950F-6288DA5283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408E035-133D-4D3C-B2F3-582FBA448D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B961580-229D-4A02-A2E3-38C288FFCB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5882F2F3-BE4E-4BE6-A8EC-28EF6469546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8E1E1621-7C51-4BA9-8E71-869403E1929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EB5389EC-305B-4E27-BE2C-1C2D6E5A67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0862F2-09E5-41ED-99C3-A82D329E9E4A}" type="datetimeFigureOut">
              <a:rPr lang="zh-CN" altLang="en-US" smtClean="0"/>
              <a:t>2022/7/6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26F00CFE-F5C0-463D-9DEF-8BDB334A22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A5C76080-583F-487C-97A8-24D2D3AB7C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14234A-F86E-403E-BAE2-B71646D6545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122726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06CF087-E93C-4A10-9031-989B68B6AD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186DDF5E-6E9A-4583-BEED-F8B28E2E3C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0862F2-09E5-41ED-99C3-A82D329E9E4A}" type="datetimeFigureOut">
              <a:rPr lang="zh-CN" altLang="en-US" smtClean="0"/>
              <a:t>2022/7/6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0A5A9FDF-6F34-48D6-A1EB-11CAD1326A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EAE78098-8D1E-441F-B47B-D04C7E9E37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14234A-F86E-403E-BAE2-B71646D6545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30192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F28DE8B7-2C1B-44DE-8B5A-26EEBE3AAF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0862F2-09E5-41ED-99C3-A82D329E9E4A}" type="datetimeFigureOut">
              <a:rPr lang="zh-CN" altLang="en-US" smtClean="0"/>
              <a:t>2022/7/6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B2E489D9-515D-4A9B-AFE8-0078CE4834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EC0A5C57-A496-49C2-9A0F-A9FF8CE2CF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14234A-F86E-403E-BAE2-B71646D6545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80309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76C4008-C819-49B7-A8DC-3AAB63E84D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9429FBD-B212-4DFA-8D22-C751F035D54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5969321-7CFC-4E2B-A6BE-C91CF5B878A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85B33DD-80CD-4B0D-938B-65F1772445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0862F2-09E5-41ED-99C3-A82D329E9E4A}" type="datetimeFigureOut">
              <a:rPr lang="zh-CN" altLang="en-US" smtClean="0"/>
              <a:t>2022/7/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1D7B4CA-4CCA-4F5A-9E6C-803592459B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0BBDFED-DC77-486D-947F-07D46E357C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14234A-F86E-403E-BAE2-B71646D6545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08407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EB8FE2D-A6B0-49D0-B429-66857E5867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9857823C-A84A-450C-B0B5-D023F3A04FB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E86F7C9-ABCA-453B-9698-316F46ED0A2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4F3E2B2-762D-4C9E-A881-D599ECE769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0862F2-09E5-41ED-99C3-A82D329E9E4A}" type="datetimeFigureOut">
              <a:rPr lang="zh-CN" altLang="en-US" smtClean="0"/>
              <a:t>2022/7/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27D55BE-21EA-474F-A751-98D9D1E2F3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D90D77C-3C66-4F9F-982B-19607BCD97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14234A-F86E-403E-BAE2-B71646D6545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150979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C160CCF0-5827-47EE-A5EF-48FA2B3DFE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A7E6F9F-1D74-48F6-B5C0-497334B00E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03A9563-75D8-4930-9DED-8FDCC046C18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0862F2-09E5-41ED-99C3-A82D329E9E4A}" type="datetimeFigureOut">
              <a:rPr lang="zh-CN" altLang="en-US" smtClean="0"/>
              <a:t>2022/7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ECAFECE-AC8D-41FC-A889-6C8497A3BC9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ED68B97-F7E8-44A7-A177-ECE4AF2FADE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14234A-F86E-403E-BAE2-B71646D6545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393641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7" Type="http://schemas.openxmlformats.org/officeDocument/2006/relationships/image" Target="../media/image8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jpeg"/><Relationship Id="rId5" Type="http://schemas.openxmlformats.org/officeDocument/2006/relationships/image" Target="../media/image6.jpeg"/><Relationship Id="rId4" Type="http://schemas.openxmlformats.org/officeDocument/2006/relationships/image" Target="../media/image5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>
            <a:extLst>
              <a:ext uri="{FF2B5EF4-FFF2-40B4-BE49-F238E27FC236}">
                <a16:creationId xmlns:a16="http://schemas.microsoft.com/office/drawing/2014/main" id="{D9701B1D-C195-4896-8DC0-6FC85AD5CF6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00137" y="471487"/>
            <a:ext cx="9991725" cy="5915025"/>
          </a:xfrm>
          <a:prstGeom prst="rect">
            <a:avLst/>
          </a:prstGeom>
        </p:spPr>
      </p:pic>
      <p:sp>
        <p:nvSpPr>
          <p:cNvPr id="11" name="Titel 4">
            <a:extLst>
              <a:ext uri="{FF2B5EF4-FFF2-40B4-BE49-F238E27FC236}">
                <a16:creationId xmlns:a16="http://schemas.microsoft.com/office/drawing/2014/main" id="{6769E655-6997-4DCC-9E24-E28DFF51ED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0"/>
            <a:ext cx="2503714" cy="533400"/>
          </a:xfrm>
        </p:spPr>
        <p:txBody>
          <a:bodyPr>
            <a:normAutofit/>
          </a:bodyPr>
          <a:lstStyle/>
          <a:p>
            <a:r>
              <a:rPr lang="en-US" altLang="nl-NL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</a:t>
            </a:r>
            <a:r>
              <a:rPr lang="en-US" altLang="zh-CN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S-1</a:t>
            </a:r>
            <a:endParaRPr lang="en-US" altLang="nl-NL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  <p:transition advTm="16448"/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72279B49-12CD-43BE-B030-C6D6981D0D6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62037" y="419100"/>
            <a:ext cx="10067925" cy="6019800"/>
          </a:xfrm>
          <a:prstGeom prst="rect">
            <a:avLst/>
          </a:prstGeom>
        </p:spPr>
      </p:pic>
      <p:sp>
        <p:nvSpPr>
          <p:cNvPr id="6" name="Titel 4">
            <a:extLst>
              <a:ext uri="{FF2B5EF4-FFF2-40B4-BE49-F238E27FC236}">
                <a16:creationId xmlns:a16="http://schemas.microsoft.com/office/drawing/2014/main" id="{BB5412F3-9CB5-4036-B6D8-3D861FC1C8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0"/>
            <a:ext cx="2503714" cy="533400"/>
          </a:xfrm>
        </p:spPr>
        <p:txBody>
          <a:bodyPr>
            <a:normAutofit/>
          </a:bodyPr>
          <a:lstStyle/>
          <a:p>
            <a:r>
              <a:rPr lang="en-US" altLang="nl-NL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</a:t>
            </a:r>
            <a:r>
              <a:rPr lang="en-US" altLang="zh-CN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S-2</a:t>
            </a:r>
            <a:endParaRPr lang="en-US" altLang="nl-NL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5227779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文本框 19">
            <a:extLst>
              <a:ext uri="{FF2B5EF4-FFF2-40B4-BE49-F238E27FC236}">
                <a16:creationId xmlns:a16="http://schemas.microsoft.com/office/drawing/2014/main" id="{56674B6E-411E-4FDD-A4BF-A98DD460E5FE}"/>
              </a:ext>
            </a:extLst>
          </p:cNvPr>
          <p:cNvSpPr txBox="1"/>
          <p:nvPr/>
        </p:nvSpPr>
        <p:spPr>
          <a:xfrm>
            <a:off x="-1" y="0"/>
            <a:ext cx="26887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-3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EB50BBB6-4910-42AA-B77B-BB639CF387F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23950" y="433387"/>
            <a:ext cx="9944100" cy="59912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8918517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文本框 21">
            <a:extLst>
              <a:ext uri="{FF2B5EF4-FFF2-40B4-BE49-F238E27FC236}">
                <a16:creationId xmlns:a16="http://schemas.microsoft.com/office/drawing/2014/main" id="{D0D7EB09-39D9-4510-97BB-850D8C0657CF}"/>
              </a:ext>
            </a:extLst>
          </p:cNvPr>
          <p:cNvSpPr txBox="1"/>
          <p:nvPr/>
        </p:nvSpPr>
        <p:spPr>
          <a:xfrm>
            <a:off x="0" y="63500"/>
            <a:ext cx="21539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-4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3" name="组合 32">
            <a:extLst>
              <a:ext uri="{FF2B5EF4-FFF2-40B4-BE49-F238E27FC236}">
                <a16:creationId xmlns:a16="http://schemas.microsoft.com/office/drawing/2014/main" id="{A8A10DDE-9F63-4F8A-95BC-1734A11A78BE}"/>
              </a:ext>
            </a:extLst>
          </p:cNvPr>
          <p:cNvGrpSpPr/>
          <p:nvPr/>
        </p:nvGrpSpPr>
        <p:grpSpPr>
          <a:xfrm>
            <a:off x="527359" y="720099"/>
            <a:ext cx="11249057" cy="4976289"/>
            <a:chOff x="527359" y="720099"/>
            <a:chExt cx="11249057" cy="4976289"/>
          </a:xfrm>
        </p:grpSpPr>
        <p:grpSp>
          <p:nvGrpSpPr>
            <p:cNvPr id="4" name="组合 3">
              <a:extLst>
                <a:ext uri="{FF2B5EF4-FFF2-40B4-BE49-F238E27FC236}">
                  <a16:creationId xmlns:a16="http://schemas.microsoft.com/office/drawing/2014/main" id="{401F549A-436D-4D65-82F6-68316DD231A2}"/>
                </a:ext>
              </a:extLst>
            </p:cNvPr>
            <p:cNvGrpSpPr/>
            <p:nvPr/>
          </p:nvGrpSpPr>
          <p:grpSpPr>
            <a:xfrm>
              <a:off x="985954" y="720099"/>
              <a:ext cx="10790462" cy="4976289"/>
              <a:chOff x="495300" y="84480"/>
              <a:chExt cx="10790462" cy="4976289"/>
            </a:xfrm>
          </p:grpSpPr>
          <p:pic>
            <p:nvPicPr>
              <p:cNvPr id="3" name="图片 2">
                <a:extLst>
                  <a:ext uri="{FF2B5EF4-FFF2-40B4-BE49-F238E27FC236}">
                    <a16:creationId xmlns:a16="http://schemas.microsoft.com/office/drawing/2014/main" id="{73B37C8A-A74F-4B1F-8AB4-DAAE0098179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635" t="66044" r="53437"/>
              <a:stretch/>
            </p:blipFill>
            <p:spPr>
              <a:xfrm>
                <a:off x="8158963" y="416944"/>
                <a:ext cx="3126799" cy="1993900"/>
              </a:xfrm>
              <a:prstGeom prst="rect">
                <a:avLst/>
              </a:prstGeom>
            </p:spPr>
          </p:pic>
          <p:pic>
            <p:nvPicPr>
              <p:cNvPr id="5" name="图片 4">
                <a:extLst>
                  <a:ext uri="{FF2B5EF4-FFF2-40B4-BE49-F238E27FC236}">
                    <a16:creationId xmlns:a16="http://schemas.microsoft.com/office/drawing/2014/main" id="{1D850271-A5BE-4D8E-89DF-FBE8C5FC630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" b="66149"/>
              <a:stretch/>
            </p:blipFill>
            <p:spPr>
              <a:xfrm>
                <a:off x="495300" y="416944"/>
                <a:ext cx="7663663" cy="1993900"/>
              </a:xfrm>
              <a:prstGeom prst="rect">
                <a:avLst/>
              </a:prstGeom>
            </p:spPr>
          </p:pic>
          <p:pic>
            <p:nvPicPr>
              <p:cNvPr id="10" name="图片 9">
                <a:extLst>
                  <a:ext uri="{FF2B5EF4-FFF2-40B4-BE49-F238E27FC236}">
                    <a16:creationId xmlns:a16="http://schemas.microsoft.com/office/drawing/2014/main" id="{04FFF0A6-6156-49BD-8AC5-8ADC6A444E2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596" t="24748" r="19013" b="67018"/>
              <a:stretch/>
            </p:blipFill>
            <p:spPr>
              <a:xfrm>
                <a:off x="6015710" y="2623562"/>
                <a:ext cx="3569045" cy="564571"/>
              </a:xfrm>
              <a:prstGeom prst="rect">
                <a:avLst/>
              </a:prstGeom>
            </p:spPr>
          </p:pic>
          <p:pic>
            <p:nvPicPr>
              <p:cNvPr id="11" name="图片 10">
                <a:extLst>
                  <a:ext uri="{FF2B5EF4-FFF2-40B4-BE49-F238E27FC236}">
                    <a16:creationId xmlns:a16="http://schemas.microsoft.com/office/drawing/2014/main" id="{46AB2359-6B66-4BE3-9A8E-C13C50FA354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353" t="44013" r="19256" b="48023"/>
              <a:stretch/>
            </p:blipFill>
            <p:spPr>
              <a:xfrm>
                <a:off x="6015710" y="3399233"/>
                <a:ext cx="3569045" cy="546101"/>
              </a:xfrm>
              <a:prstGeom prst="rect">
                <a:avLst/>
              </a:prstGeom>
            </p:spPr>
          </p:pic>
          <p:pic>
            <p:nvPicPr>
              <p:cNvPr id="12" name="图片 11">
                <a:extLst>
                  <a:ext uri="{FF2B5EF4-FFF2-40B4-BE49-F238E27FC236}">
                    <a16:creationId xmlns:a16="http://schemas.microsoft.com/office/drawing/2014/main" id="{3F04AAA5-B8FF-4602-9632-69C7BFC6B49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275" t="64630" r="35552" b="27407"/>
              <a:stretch/>
            </p:blipFill>
            <p:spPr>
              <a:xfrm>
                <a:off x="6015710" y="4186682"/>
                <a:ext cx="2889251" cy="546100"/>
              </a:xfrm>
              <a:prstGeom prst="rect">
                <a:avLst/>
              </a:prstGeom>
            </p:spPr>
          </p:pic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3E5445A0-4CD4-479C-8C8F-DFC867F831BE}"/>
                  </a:ext>
                </a:extLst>
              </p:cNvPr>
              <p:cNvSpPr txBox="1"/>
              <p:nvPr/>
            </p:nvSpPr>
            <p:spPr>
              <a:xfrm>
                <a:off x="6973012" y="4673953"/>
                <a:ext cx="101457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 min</a:t>
                </a:r>
                <a:endParaRPr lang="zh-CN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" name="文本框 5">
                <a:extLst>
                  <a:ext uri="{FF2B5EF4-FFF2-40B4-BE49-F238E27FC236}">
                    <a16:creationId xmlns:a16="http://schemas.microsoft.com/office/drawing/2014/main" id="{39786A8E-3B1E-4E69-928F-1944EEC929EC}"/>
                  </a:ext>
                </a:extLst>
              </p:cNvPr>
              <p:cNvSpPr txBox="1"/>
              <p:nvPr/>
            </p:nvSpPr>
            <p:spPr>
              <a:xfrm>
                <a:off x="1003300" y="338898"/>
                <a:ext cx="98171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      4     5     8     10   13   19    w             2     6     9    11   12    14   21   w         3     7    16    18   15   w</a:t>
                </a:r>
                <a:endParaRPr lang="zh-CN" altLang="en-US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文本框 15">
                <a:extLst>
                  <a:ext uri="{FF2B5EF4-FFF2-40B4-BE49-F238E27FC236}">
                    <a16:creationId xmlns:a16="http://schemas.microsoft.com/office/drawing/2014/main" id="{30634096-423C-4361-9AE9-DD524B7C74D9}"/>
                  </a:ext>
                </a:extLst>
              </p:cNvPr>
              <p:cNvSpPr txBox="1"/>
              <p:nvPr/>
            </p:nvSpPr>
            <p:spPr>
              <a:xfrm>
                <a:off x="5032164" y="84480"/>
                <a:ext cx="101457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 min</a:t>
                </a:r>
                <a:endParaRPr lang="zh-CN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17" name="图片 16">
                <a:extLst>
                  <a:ext uri="{FF2B5EF4-FFF2-40B4-BE49-F238E27FC236}">
                    <a16:creationId xmlns:a16="http://schemas.microsoft.com/office/drawing/2014/main" id="{E8B8EBD8-C23D-4D9D-BD25-B0369B000FF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182" t="30751" r="13239" b="59830"/>
              <a:stretch/>
            </p:blipFill>
            <p:spPr>
              <a:xfrm>
                <a:off x="1687599" y="2647721"/>
                <a:ext cx="3352800" cy="564570"/>
              </a:xfrm>
              <a:prstGeom prst="rect">
                <a:avLst/>
              </a:prstGeom>
            </p:spPr>
          </p:pic>
          <p:pic>
            <p:nvPicPr>
              <p:cNvPr id="18" name="图片 17">
                <a:extLst>
                  <a:ext uri="{FF2B5EF4-FFF2-40B4-BE49-F238E27FC236}">
                    <a16:creationId xmlns:a16="http://schemas.microsoft.com/office/drawing/2014/main" id="{CEC3B8CC-FC0B-4F1E-90AD-0E51D410C79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182" t="50456" r="13239" b="40433"/>
              <a:stretch/>
            </p:blipFill>
            <p:spPr>
              <a:xfrm>
                <a:off x="1687599" y="3420017"/>
                <a:ext cx="3352800" cy="546100"/>
              </a:xfrm>
              <a:prstGeom prst="rect">
                <a:avLst/>
              </a:prstGeom>
            </p:spPr>
          </p:pic>
          <p:pic>
            <p:nvPicPr>
              <p:cNvPr id="19" name="图片 18">
                <a:extLst>
                  <a:ext uri="{FF2B5EF4-FFF2-40B4-BE49-F238E27FC236}">
                    <a16:creationId xmlns:a16="http://schemas.microsoft.com/office/drawing/2014/main" id="{2376428C-7570-4EBB-889C-4A1113A72EF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543" t="71999" r="31872" b="18890"/>
              <a:stretch/>
            </p:blipFill>
            <p:spPr>
              <a:xfrm>
                <a:off x="1687599" y="4197568"/>
                <a:ext cx="2768600" cy="546100"/>
              </a:xfrm>
              <a:prstGeom prst="rect">
                <a:avLst/>
              </a:prstGeom>
            </p:spPr>
          </p:pic>
          <p:sp>
            <p:nvSpPr>
              <p:cNvPr id="20" name="文本框 19">
                <a:extLst>
                  <a:ext uri="{FF2B5EF4-FFF2-40B4-BE49-F238E27FC236}">
                    <a16:creationId xmlns:a16="http://schemas.microsoft.com/office/drawing/2014/main" id="{5D93FFCD-5B78-4DBB-9D93-C04E2B642D1C}"/>
                  </a:ext>
                </a:extLst>
              </p:cNvPr>
              <p:cNvSpPr txBox="1"/>
              <p:nvPr/>
            </p:nvSpPr>
            <p:spPr>
              <a:xfrm>
                <a:off x="2940987" y="4691437"/>
                <a:ext cx="57481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 </a:t>
                </a:r>
                <a:endParaRPr lang="zh-CN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" name="文本框 1">
                <a:extLst>
                  <a:ext uri="{FF2B5EF4-FFF2-40B4-BE49-F238E27FC236}">
                    <a16:creationId xmlns:a16="http://schemas.microsoft.com/office/drawing/2014/main" id="{CC8B9B85-5EDB-4AAE-8EE2-0EC4E19FFF2D}"/>
                  </a:ext>
                </a:extLst>
              </p:cNvPr>
              <p:cNvSpPr txBox="1"/>
              <p:nvPr/>
            </p:nvSpPr>
            <p:spPr>
              <a:xfrm>
                <a:off x="1687598" y="2393837"/>
                <a:ext cx="367905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1      4       5       8       10      13     19    water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文本框 20">
                <a:extLst>
                  <a:ext uri="{FF2B5EF4-FFF2-40B4-BE49-F238E27FC236}">
                    <a16:creationId xmlns:a16="http://schemas.microsoft.com/office/drawing/2014/main" id="{9A408B77-9CCD-43BE-8833-0EA3EC287707}"/>
                  </a:ext>
                </a:extLst>
              </p:cNvPr>
              <p:cNvSpPr txBox="1"/>
              <p:nvPr/>
            </p:nvSpPr>
            <p:spPr>
              <a:xfrm>
                <a:off x="1687598" y="3157846"/>
                <a:ext cx="367905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2       6       9      11     12     14      21    water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文本框 22">
                <a:extLst>
                  <a:ext uri="{FF2B5EF4-FFF2-40B4-BE49-F238E27FC236}">
                    <a16:creationId xmlns:a16="http://schemas.microsoft.com/office/drawing/2014/main" id="{36A43AC7-25CF-474B-AC9E-4CE2316F928C}"/>
                  </a:ext>
                </a:extLst>
              </p:cNvPr>
              <p:cNvSpPr txBox="1"/>
              <p:nvPr/>
            </p:nvSpPr>
            <p:spPr>
              <a:xfrm>
                <a:off x="1709366" y="3895699"/>
                <a:ext cx="367905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/>
                  <a:t>   </a:t>
                </a:r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        7       16     18     15    water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文本框 23">
                <a:extLst>
                  <a:ext uri="{FF2B5EF4-FFF2-40B4-BE49-F238E27FC236}">
                    <a16:creationId xmlns:a16="http://schemas.microsoft.com/office/drawing/2014/main" id="{89C008C6-E2BE-4060-84EA-12E0CA38EC3B}"/>
                  </a:ext>
                </a:extLst>
              </p:cNvPr>
              <p:cNvSpPr txBox="1"/>
              <p:nvPr/>
            </p:nvSpPr>
            <p:spPr>
              <a:xfrm>
                <a:off x="6046740" y="2375394"/>
                <a:ext cx="367905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         4        5        8      10       13      19    water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id="{5B2B8316-0B72-45A8-8E75-4999C9BC08F8}"/>
                  </a:ext>
                </a:extLst>
              </p:cNvPr>
              <p:cNvSpPr txBox="1"/>
              <p:nvPr/>
            </p:nvSpPr>
            <p:spPr>
              <a:xfrm>
                <a:off x="6046740" y="3134598"/>
                <a:ext cx="418706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         6        9        11     12      14       21    water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C58C03DE-887D-49AF-AA7B-CB027ECC4EB6}"/>
                  </a:ext>
                </a:extLst>
              </p:cNvPr>
              <p:cNvSpPr txBox="1"/>
              <p:nvPr/>
            </p:nvSpPr>
            <p:spPr>
              <a:xfrm>
                <a:off x="6096000" y="3873076"/>
                <a:ext cx="324394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/>
                  <a:t>  </a:t>
                </a:r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        7       16       18      15    water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5" name="组合 14">
              <a:extLst>
                <a:ext uri="{FF2B5EF4-FFF2-40B4-BE49-F238E27FC236}">
                  <a16:creationId xmlns:a16="http://schemas.microsoft.com/office/drawing/2014/main" id="{79C6EFB0-312A-478A-B26E-1B16B74064E8}"/>
                </a:ext>
              </a:extLst>
            </p:cNvPr>
            <p:cNvGrpSpPr/>
            <p:nvPr/>
          </p:nvGrpSpPr>
          <p:grpSpPr>
            <a:xfrm>
              <a:off x="527359" y="2174042"/>
              <a:ext cx="458595" cy="246221"/>
              <a:chOff x="527359" y="2174042"/>
              <a:chExt cx="458595" cy="246221"/>
            </a:xfrm>
          </p:grpSpPr>
          <p:cxnSp>
            <p:nvCxnSpPr>
              <p:cNvPr id="8" name="直接箭头连接符 7">
                <a:extLst>
                  <a:ext uri="{FF2B5EF4-FFF2-40B4-BE49-F238E27FC236}">
                    <a16:creationId xmlns:a16="http://schemas.microsoft.com/office/drawing/2014/main" id="{64759869-A130-4026-B8EF-1FEB4AD4BBB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25190" y="2297153"/>
                <a:ext cx="160764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FAC8F066-F8A8-496A-9B98-72EC87853C5A}"/>
                  </a:ext>
                </a:extLst>
              </p:cNvPr>
              <p:cNvSpPr txBox="1"/>
              <p:nvPr/>
            </p:nvSpPr>
            <p:spPr>
              <a:xfrm>
                <a:off x="527359" y="2174042"/>
                <a:ext cx="43489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7" name="组合 26">
              <a:extLst>
                <a:ext uri="{FF2B5EF4-FFF2-40B4-BE49-F238E27FC236}">
                  <a16:creationId xmlns:a16="http://schemas.microsoft.com/office/drawing/2014/main" id="{B7DF75B1-6E1F-4DB9-97E2-1166763CD59C}"/>
                </a:ext>
              </a:extLst>
            </p:cNvPr>
            <p:cNvGrpSpPr/>
            <p:nvPr/>
          </p:nvGrpSpPr>
          <p:grpSpPr>
            <a:xfrm>
              <a:off x="527359" y="1930846"/>
              <a:ext cx="458595" cy="246221"/>
              <a:chOff x="527359" y="2174042"/>
              <a:chExt cx="458595" cy="246221"/>
            </a:xfrm>
          </p:grpSpPr>
          <p:cxnSp>
            <p:nvCxnSpPr>
              <p:cNvPr id="28" name="直接箭头连接符 27">
                <a:extLst>
                  <a:ext uri="{FF2B5EF4-FFF2-40B4-BE49-F238E27FC236}">
                    <a16:creationId xmlns:a16="http://schemas.microsoft.com/office/drawing/2014/main" id="{77522B33-386B-43E1-9E67-896935AF5E8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25190" y="2297153"/>
                <a:ext cx="160764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3F336B96-6132-4FDE-BEAF-3AA2100793BB}"/>
                  </a:ext>
                </a:extLst>
              </p:cNvPr>
              <p:cNvSpPr txBox="1"/>
              <p:nvPr/>
            </p:nvSpPr>
            <p:spPr>
              <a:xfrm>
                <a:off x="527359" y="2174042"/>
                <a:ext cx="43489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0</a:t>
                </a:r>
                <a:endPara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30" name="组合 29">
              <a:extLst>
                <a:ext uri="{FF2B5EF4-FFF2-40B4-BE49-F238E27FC236}">
                  <a16:creationId xmlns:a16="http://schemas.microsoft.com/office/drawing/2014/main" id="{E120B34D-A73D-4C54-964B-7C92C2FB090D}"/>
                </a:ext>
              </a:extLst>
            </p:cNvPr>
            <p:cNvGrpSpPr/>
            <p:nvPr/>
          </p:nvGrpSpPr>
          <p:grpSpPr>
            <a:xfrm>
              <a:off x="538510" y="1779633"/>
              <a:ext cx="447444" cy="246221"/>
              <a:chOff x="538510" y="2174042"/>
              <a:chExt cx="447444" cy="246221"/>
            </a:xfrm>
          </p:grpSpPr>
          <p:cxnSp>
            <p:nvCxnSpPr>
              <p:cNvPr id="31" name="直接箭头连接符 30">
                <a:extLst>
                  <a:ext uri="{FF2B5EF4-FFF2-40B4-BE49-F238E27FC236}">
                    <a16:creationId xmlns:a16="http://schemas.microsoft.com/office/drawing/2014/main" id="{167D1BC6-70B6-4B63-9D9C-0DB8A9903F8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25190" y="2297153"/>
                <a:ext cx="160764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id="{7D9B39D3-5B10-4AF2-8284-009193739A08}"/>
                  </a:ext>
                </a:extLst>
              </p:cNvPr>
              <p:cNvSpPr txBox="1"/>
              <p:nvPr/>
            </p:nvSpPr>
            <p:spPr>
              <a:xfrm>
                <a:off x="538510" y="2174042"/>
                <a:ext cx="43489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00</a:t>
                </a:r>
                <a:endPara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68729608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>
            <a:extLst>
              <a:ext uri="{FF2B5EF4-FFF2-40B4-BE49-F238E27FC236}">
                <a16:creationId xmlns:a16="http://schemas.microsoft.com/office/drawing/2014/main" id="{D5E56E5A-EFB6-4F8C-846B-B39F8E5588EA}"/>
              </a:ext>
            </a:extLst>
          </p:cNvPr>
          <p:cNvGrpSpPr/>
          <p:nvPr/>
        </p:nvGrpSpPr>
        <p:grpSpPr>
          <a:xfrm>
            <a:off x="1704821" y="0"/>
            <a:ext cx="8782358" cy="6858000"/>
            <a:chOff x="1704821" y="0"/>
            <a:chExt cx="8782358" cy="6858000"/>
          </a:xfrm>
        </p:grpSpPr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12F18571-E91E-475D-B631-BF828D16AB7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04821" y="0"/>
              <a:ext cx="8782358" cy="6858000"/>
            </a:xfrm>
            <a:prstGeom prst="rect">
              <a:avLst/>
            </a:prstGeom>
          </p:spPr>
        </p:pic>
        <p:sp>
          <p:nvSpPr>
            <p:cNvPr id="2" name="矩形 1">
              <a:extLst>
                <a:ext uri="{FF2B5EF4-FFF2-40B4-BE49-F238E27FC236}">
                  <a16:creationId xmlns:a16="http://schemas.microsoft.com/office/drawing/2014/main" id="{E9073E62-7DDA-4458-8E76-51EB12DCBB4E}"/>
                </a:ext>
              </a:extLst>
            </p:cNvPr>
            <p:cNvSpPr/>
            <p:nvPr/>
          </p:nvSpPr>
          <p:spPr>
            <a:xfrm>
              <a:off x="7559040" y="95693"/>
              <a:ext cx="2761631" cy="50746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BS 146623 T. indotineae</a:t>
              </a:r>
              <a:endParaRPr lang="zh-CN" altLang="en-US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矩形 3">
              <a:extLst>
                <a:ext uri="{FF2B5EF4-FFF2-40B4-BE49-F238E27FC236}">
                  <a16:creationId xmlns:a16="http://schemas.microsoft.com/office/drawing/2014/main" id="{A8377C11-0A98-4431-B753-9476469509DE}"/>
                </a:ext>
              </a:extLst>
            </p:cNvPr>
            <p:cNvSpPr/>
            <p:nvPr/>
          </p:nvSpPr>
          <p:spPr>
            <a:xfrm>
              <a:off x="7091680" y="2361901"/>
              <a:ext cx="3228991" cy="50746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CBS 428.63 T. interdigitale</a:t>
              </a:r>
              <a:endParaRPr lang="zh-CN" altLang="en-US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矩形 5">
              <a:extLst>
                <a:ext uri="{FF2B5EF4-FFF2-40B4-BE49-F238E27FC236}">
                  <a16:creationId xmlns:a16="http://schemas.microsoft.com/office/drawing/2014/main" id="{C7C0AE7F-4CFC-4321-BC8E-025EF09F75D1}"/>
                </a:ext>
              </a:extLst>
            </p:cNvPr>
            <p:cNvSpPr/>
            <p:nvPr/>
          </p:nvSpPr>
          <p:spPr>
            <a:xfrm>
              <a:off x="6522720" y="4562104"/>
              <a:ext cx="3797951" cy="50746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   CBS 124421 T. mentagrophytes</a:t>
              </a:r>
              <a:endParaRPr lang="zh-CN" altLang="en-US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0" name="文本框 9">
            <a:extLst>
              <a:ext uri="{FF2B5EF4-FFF2-40B4-BE49-F238E27FC236}">
                <a16:creationId xmlns:a16="http://schemas.microsoft.com/office/drawing/2014/main" id="{A28F237C-50F8-478E-8C00-16DE80FCAFC9}"/>
              </a:ext>
            </a:extLst>
          </p:cNvPr>
          <p:cNvSpPr txBox="1"/>
          <p:nvPr/>
        </p:nvSpPr>
        <p:spPr>
          <a:xfrm>
            <a:off x="111111" y="0"/>
            <a:ext cx="142720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-5</a:t>
            </a:r>
            <a:endParaRPr lang="zh-CN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1087338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文本框 16">
            <a:extLst>
              <a:ext uri="{FF2B5EF4-FFF2-40B4-BE49-F238E27FC236}">
                <a16:creationId xmlns:a16="http://schemas.microsoft.com/office/drawing/2014/main" id="{BFB3BC7E-9ED8-49EA-8C16-BBCD120EEC4A}"/>
              </a:ext>
            </a:extLst>
          </p:cNvPr>
          <p:cNvSpPr txBox="1"/>
          <p:nvPr/>
        </p:nvSpPr>
        <p:spPr>
          <a:xfrm>
            <a:off x="0" y="73681"/>
            <a:ext cx="1174496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indent="266700" algn="just"/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. S-6</a:t>
            </a:r>
            <a:endParaRPr lang="zh-CN" altLang="zh-CN" sz="18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grpSp>
        <p:nvGrpSpPr>
          <p:cNvPr id="3" name="组合 2">
            <a:extLst>
              <a:ext uri="{FF2B5EF4-FFF2-40B4-BE49-F238E27FC236}">
                <a16:creationId xmlns:a16="http://schemas.microsoft.com/office/drawing/2014/main" id="{C4C231E4-C40A-4AEC-8776-B4CC7A38398B}"/>
              </a:ext>
            </a:extLst>
          </p:cNvPr>
          <p:cNvGrpSpPr/>
          <p:nvPr/>
        </p:nvGrpSpPr>
        <p:grpSpPr>
          <a:xfrm>
            <a:off x="0" y="1474718"/>
            <a:ext cx="12047717" cy="3663111"/>
            <a:chOff x="0" y="1474718"/>
            <a:chExt cx="12047717" cy="3663111"/>
          </a:xfrm>
        </p:grpSpPr>
        <p:grpSp>
          <p:nvGrpSpPr>
            <p:cNvPr id="15" name="组合 14">
              <a:extLst>
                <a:ext uri="{FF2B5EF4-FFF2-40B4-BE49-F238E27FC236}">
                  <a16:creationId xmlns:a16="http://schemas.microsoft.com/office/drawing/2014/main" id="{6C0018D8-5AE3-448E-A170-C61EEDD4C0F1}"/>
                </a:ext>
              </a:extLst>
            </p:cNvPr>
            <p:cNvGrpSpPr/>
            <p:nvPr/>
          </p:nvGrpSpPr>
          <p:grpSpPr>
            <a:xfrm>
              <a:off x="0" y="1617570"/>
              <a:ext cx="12047717" cy="3520259"/>
              <a:chOff x="-105385" y="1622410"/>
              <a:chExt cx="12047717" cy="3520259"/>
            </a:xfrm>
          </p:grpSpPr>
          <p:sp>
            <p:nvSpPr>
              <p:cNvPr id="10" name="文本框 9">
                <a:extLst>
                  <a:ext uri="{FF2B5EF4-FFF2-40B4-BE49-F238E27FC236}">
                    <a16:creationId xmlns:a16="http://schemas.microsoft.com/office/drawing/2014/main" id="{00D55096-7BC9-4C31-A4A8-931B383E17F1}"/>
                  </a:ext>
                </a:extLst>
              </p:cNvPr>
              <p:cNvSpPr txBox="1"/>
              <p:nvPr/>
            </p:nvSpPr>
            <p:spPr>
              <a:xfrm>
                <a:off x="-105385" y="1622410"/>
                <a:ext cx="2616038" cy="35202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>
                  <a:lnSpc>
                    <a:spcPct val="150000"/>
                  </a:lnSpc>
                </a:pPr>
                <a:r>
                  <a:rPr lang="en-US" altLang="zh-CN" sz="1250" i="1" kern="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T. </a:t>
                </a:r>
                <a:r>
                  <a:rPr lang="en-US" altLang="zh-CN" sz="1250" i="1" kern="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i</a:t>
                </a:r>
                <a:r>
                  <a:rPr lang="en-US" altLang="zh-CN" sz="1250" i="1" kern="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nterdigitale </a:t>
                </a:r>
                <a:r>
                  <a:rPr lang="en-US" altLang="zh-CN" sz="1250" kern="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CBS 428.6</a:t>
                </a:r>
                <a:endParaRPr lang="en-US" altLang="zh-CN" sz="1250" kern="0" dirty="0">
                  <a:solidFill>
                    <a:srgbClr val="000000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endParaRPr>
              </a:p>
              <a:p>
                <a:pPr algn="r">
                  <a:lnSpc>
                    <a:spcPct val="150000"/>
                  </a:lnSpc>
                </a:pPr>
                <a:r>
                  <a:rPr lang="en-US" altLang="zh-CN" sz="1250" i="1" kern="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T. </a:t>
                </a:r>
                <a:r>
                  <a:rPr lang="en-US" altLang="zh-CN" sz="1250" i="1" kern="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i</a:t>
                </a:r>
                <a:r>
                  <a:rPr lang="en-US" altLang="zh-CN" sz="1250" i="1" kern="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nterdigitale</a:t>
                </a:r>
                <a:r>
                  <a:rPr lang="en-US" altLang="zh-CN" sz="1250" kern="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  II 200070/17</a:t>
                </a:r>
              </a:p>
              <a:p>
                <a:pPr algn="r">
                  <a:lnSpc>
                    <a:spcPct val="150000"/>
                  </a:lnSpc>
                </a:pPr>
                <a:r>
                  <a:rPr lang="en-US" altLang="zh-CN" sz="1250" i="1" kern="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T. </a:t>
                </a:r>
                <a:r>
                  <a:rPr lang="en-US" altLang="zh-CN" sz="1250" i="1" kern="0" dirty="0" err="1">
                    <a:solidFill>
                      <a:srgbClr val="000000"/>
                    </a:solidFill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m</a:t>
                </a:r>
                <a:r>
                  <a:rPr lang="en-US" altLang="zh-CN" sz="1250" i="1" kern="0" dirty="0" err="1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entagrophtyes</a:t>
                </a:r>
                <a:r>
                  <a:rPr lang="en-US" altLang="zh-CN" sz="1250" i="1" kern="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 </a:t>
                </a:r>
                <a:r>
                  <a:rPr lang="en-US" altLang="zh-CN" sz="1250" kern="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III 217704/15</a:t>
                </a:r>
              </a:p>
              <a:p>
                <a:pPr algn="r">
                  <a:lnSpc>
                    <a:spcPct val="150000"/>
                  </a:lnSpc>
                </a:pPr>
                <a:r>
                  <a:rPr lang="en-US" altLang="zh-CN" sz="1250" i="1" kern="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T. mentagrophytes </a:t>
                </a:r>
                <a:r>
                  <a:rPr lang="en-US" altLang="zh-CN" sz="1250" kern="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III</a:t>
                </a:r>
                <a:r>
                  <a:rPr lang="zh-CN" altLang="en-US" sz="1250" kern="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*</a:t>
                </a:r>
                <a:r>
                  <a:rPr lang="en-US" altLang="zh-CN" sz="1250" kern="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 </a:t>
                </a:r>
                <a:r>
                  <a:rPr lang="en-US" altLang="zh-CN" sz="1250" kern="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IHEM4268</a:t>
                </a:r>
              </a:p>
              <a:p>
                <a:pPr algn="r">
                  <a:lnSpc>
                    <a:spcPct val="150000"/>
                  </a:lnSpc>
                </a:pPr>
                <a:r>
                  <a:rPr lang="en-US" altLang="zh-CN" sz="1250" i="1" kern="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T. </a:t>
                </a:r>
                <a:r>
                  <a:rPr lang="en-US" altLang="zh-CN" sz="1250" i="1" kern="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m</a:t>
                </a:r>
                <a:r>
                  <a:rPr lang="en-US" altLang="zh-CN" sz="1250" i="1" kern="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entagrophytes </a:t>
                </a:r>
                <a:r>
                  <a:rPr lang="en-US" altLang="zh-CN" sz="1250" kern="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IV </a:t>
                </a:r>
                <a:r>
                  <a:rPr lang="en-US" altLang="zh-CN" sz="1250" kern="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200602/17</a:t>
                </a:r>
              </a:p>
              <a:p>
                <a:pPr algn="r">
                  <a:lnSpc>
                    <a:spcPct val="150000"/>
                  </a:lnSpc>
                </a:pPr>
                <a:r>
                  <a:rPr lang="en-US" altLang="zh-CN" sz="1250" i="1" kern="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T. </a:t>
                </a:r>
                <a:r>
                  <a:rPr lang="en-US" altLang="zh-CN" sz="1250" i="1" kern="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m</a:t>
                </a:r>
                <a:r>
                  <a:rPr lang="en-US" altLang="zh-CN" sz="1250" i="1" kern="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entagrophytes</a:t>
                </a:r>
                <a:r>
                  <a:rPr lang="en-US" altLang="zh-CN" sz="1250" kern="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 VII </a:t>
                </a:r>
                <a:r>
                  <a:rPr lang="en-US" altLang="zh-CN" sz="1250" kern="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210363/16</a:t>
                </a:r>
              </a:p>
              <a:p>
                <a:pPr algn="r">
                  <a:lnSpc>
                    <a:spcPct val="150000"/>
                  </a:lnSpc>
                </a:pPr>
                <a:r>
                  <a:rPr lang="en-US" altLang="zh-CN" sz="1250" i="1" kern="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T. </a:t>
                </a:r>
                <a:r>
                  <a:rPr lang="en-US" altLang="zh-CN" sz="1250" i="1" kern="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m</a:t>
                </a:r>
                <a:r>
                  <a:rPr lang="en-US" altLang="zh-CN" sz="1250" i="1" kern="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entagrophytes </a:t>
                </a:r>
                <a:r>
                  <a:rPr lang="en-US" altLang="zh-CN" sz="1250" kern="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IX </a:t>
                </a:r>
                <a:r>
                  <a:rPr lang="en-US" altLang="zh-CN" sz="1250" kern="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214691/17</a:t>
                </a:r>
              </a:p>
              <a:p>
                <a:pPr algn="r">
                  <a:lnSpc>
                    <a:spcPct val="150000"/>
                  </a:lnSpc>
                </a:pPr>
                <a:r>
                  <a:rPr lang="en-US" altLang="zh-CN" sz="1250" i="1" kern="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T. </a:t>
                </a:r>
                <a:r>
                  <a:rPr lang="en-US" altLang="zh-CN" sz="1250" i="1" kern="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m</a:t>
                </a:r>
                <a:r>
                  <a:rPr lang="en-US" altLang="zh-CN" sz="1250" i="1" kern="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entagrophytes </a:t>
                </a:r>
                <a:r>
                  <a:rPr lang="en-US" altLang="zh-CN" sz="1250" kern="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IX </a:t>
                </a:r>
                <a:r>
                  <a:rPr lang="en-US" altLang="zh-CN" sz="1250" kern="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XM1</a:t>
                </a:r>
              </a:p>
              <a:p>
                <a:pPr algn="r">
                  <a:lnSpc>
                    <a:spcPct val="150000"/>
                  </a:lnSpc>
                </a:pPr>
                <a:r>
                  <a:rPr lang="en-US" altLang="zh-CN" sz="1250" i="1" kern="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T. indotineae </a:t>
                </a:r>
                <a:r>
                  <a:rPr lang="en-US" altLang="zh-CN" sz="1250" kern="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CBS 145524</a:t>
                </a:r>
              </a:p>
              <a:p>
                <a:pPr algn="r">
                  <a:lnSpc>
                    <a:spcPct val="150000"/>
                  </a:lnSpc>
                </a:pPr>
                <a:r>
                  <a:rPr lang="en-US" altLang="zh-CN" sz="1250" i="1" kern="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T. rubrum </a:t>
                </a:r>
                <a:r>
                  <a:rPr lang="en-US" altLang="zh-CN" sz="1250" kern="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CBS 392.58</a:t>
                </a:r>
              </a:p>
              <a:p>
                <a:pPr algn="r">
                  <a:lnSpc>
                    <a:spcPct val="150000"/>
                  </a:lnSpc>
                </a:pPr>
                <a:r>
                  <a:rPr lang="en-US" altLang="zh-CN" sz="1250" i="1" kern="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T. benhamiae </a:t>
                </a:r>
                <a:r>
                  <a:rPr lang="en-US" altLang="zh-CN" sz="1250" kern="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IHEM 25068</a:t>
                </a:r>
              </a:p>
              <a:p>
                <a:pPr algn="r">
                  <a:lnSpc>
                    <a:spcPct val="150000"/>
                  </a:lnSpc>
                </a:pPr>
                <a:endParaRPr lang="en-US" altLang="zh-CN" sz="1250" kern="0" dirty="0">
                  <a:solidFill>
                    <a:srgbClr val="000000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12" name="图片 11">
                <a:extLst>
                  <a:ext uri="{FF2B5EF4-FFF2-40B4-BE49-F238E27FC236}">
                    <a16:creationId xmlns:a16="http://schemas.microsoft.com/office/drawing/2014/main" id="{A7DFB025-09DF-4459-9635-33349D0D07F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7124699" y="1706037"/>
                <a:ext cx="4817633" cy="3129487"/>
              </a:xfrm>
              <a:prstGeom prst="rect">
                <a:avLst/>
              </a:prstGeom>
            </p:spPr>
          </p:pic>
          <p:pic>
            <p:nvPicPr>
              <p:cNvPr id="14" name="图片 13">
                <a:extLst>
                  <a:ext uri="{FF2B5EF4-FFF2-40B4-BE49-F238E27FC236}">
                    <a16:creationId xmlns:a16="http://schemas.microsoft.com/office/drawing/2014/main" id="{6D1D522C-38F5-4388-A81D-4EA5932C3D1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2482635" y="1706038"/>
                <a:ext cx="4494899" cy="3129486"/>
              </a:xfrm>
              <a:prstGeom prst="rect">
                <a:avLst/>
              </a:prstGeom>
            </p:spPr>
          </p:pic>
        </p:grp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C18A6AB2-0B2E-45EE-A125-47C84D042628}"/>
                </a:ext>
              </a:extLst>
            </p:cNvPr>
            <p:cNvSpPr txBox="1"/>
            <p:nvPr/>
          </p:nvSpPr>
          <p:spPr>
            <a:xfrm>
              <a:off x="2440855" y="1474718"/>
              <a:ext cx="4697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9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17C44B37-6615-4C58-9897-2C6FEE58C42C}"/>
                </a:ext>
              </a:extLst>
            </p:cNvPr>
            <p:cNvSpPr txBox="1"/>
            <p:nvPr/>
          </p:nvSpPr>
          <p:spPr>
            <a:xfrm>
              <a:off x="7082919" y="1494459"/>
              <a:ext cx="4697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0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897521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111</TotalTime>
  <Words>177</Words>
  <Application>Microsoft Office PowerPoint</Application>
  <PresentationFormat>宽屏</PresentationFormat>
  <Paragraphs>41</Paragraphs>
  <Slides>6</Slides>
  <Notes>6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1" baseType="lpstr">
      <vt:lpstr>等线</vt:lpstr>
      <vt:lpstr>等线 Light</vt:lpstr>
      <vt:lpstr>Arial</vt:lpstr>
      <vt:lpstr>Times New Roman</vt:lpstr>
      <vt:lpstr>Office 主题​​</vt:lpstr>
      <vt:lpstr>Fig. S-1</vt:lpstr>
      <vt:lpstr>Fig. S-2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esults</dc:title>
  <dc:creator>Chao Tang</dc:creator>
  <cp:lastModifiedBy>Chao Tang</cp:lastModifiedBy>
  <cp:revision>107</cp:revision>
  <dcterms:created xsi:type="dcterms:W3CDTF">2021-09-20T08:09:57Z</dcterms:created>
  <dcterms:modified xsi:type="dcterms:W3CDTF">2022-07-06T09:22:20Z</dcterms:modified>
</cp:coreProperties>
</file>